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13" r:id="rId2"/>
    <p:sldId id="1192" r:id="rId3"/>
    <p:sldId id="314" r:id="rId4"/>
    <p:sldId id="1193" r:id="rId5"/>
    <p:sldId id="330" r:id="rId6"/>
    <p:sldId id="33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12" y="8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472085-D74C-4738-8FD7-DFA7FDAB63D9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E54AC6-F7C6-490D-A815-0791E79C4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50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 Figure </a:t>
            </a:r>
            <a:r>
              <a:rPr lang="en-US" b="1" dirty="0"/>
              <a:t>1. Statistical</a:t>
            </a:r>
            <a:r>
              <a:rPr lang="en-US" sz="1400" b="1" dirty="0">
                <a:latin typeface="Times New Roman" panose="02020603050405020304" pitchFamily="18" charset="0"/>
                <a:ea typeface="DengXian" panose="02010600030101010101" pitchFamily="2" charset="-122"/>
              </a:rPr>
              <a:t> analysis of the imputation result. </a:t>
            </a:r>
            <a:endParaRPr lang="en-US" b="1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DE66D0-945B-4B7A-A6A4-6036DD2F21E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5891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 Figure 4. PHQ-9 response distribution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92F9CF-A1F9-4E8E-B17F-EF7BBC31A7B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5515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 Figure 5. Feature importance for difference rac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92F9CF-A1F9-4E8E-B17F-EF7BBC31A7B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35109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 Figure 6. Sensitivity analysis on race disparity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White as privileg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92F9CF-A1F9-4E8E-B17F-EF7BBC31A7B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9619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08335B-85B5-9C58-FC7B-8BC56C72E7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58470D-7E8F-8473-329D-70F5B21BC5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C5CE07-4E1C-BDD8-0EC9-DB91E4304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25C3AC-6457-0CAC-B90A-AEDC0B7DC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6152BC-465B-F226-8C97-1977FE857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902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CD3590-24D2-E3D9-42AF-4B10B6FD7D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13BB9F-0EDC-4673-4E62-FE1FDF2FC4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82A736-77DA-98AA-ED53-689362916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A5EFA3-2819-81EE-F5D4-3279AF201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52C87E-1598-9C95-0021-ECF80D0C8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351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1F5E82A-2326-15F2-FFF5-00E8A5822D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68F639-42CA-6DC8-DF94-2C16BB7796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6EABD9-75DA-BD43-2CB0-9E3CD3E1B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3EBF16-2898-A53A-85BD-06F4B439D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C3A0BB-2733-9B9D-7EC8-C5FF5BCD8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395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A2BD9A-2EC8-2321-926C-A7BD2E5B3B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B0E7AF-1C59-6064-8B60-AFECB8892A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57446B-2350-2EF0-72F4-7110FE694F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30AB89-2478-E553-C37E-9A608D208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FE0FAF-1AB9-C202-4E7A-187255303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685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D6D1C0-AD44-F449-648D-D38A9E8C9C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8E4BBA-D112-EFE6-1E5E-1E9566495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11EA4D-FE40-ED92-D805-52AA86990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124BFC-2417-66E0-2FFF-967BA74BDD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55EC5A-29FB-2758-E17A-4C61F66FA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022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8376E1-19EC-D39E-22B5-F01641DB44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40B4EF-1F53-579B-9F82-1D09AD2C6D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2838BF-5599-13FD-6761-CCE7D3054A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D9384C-A154-295B-C69E-F593989FF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84A893-B45F-BCF8-7885-F31DA3DDE9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BBE0D0-EB22-D48B-1DAC-127D7ECB9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36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E5256F-7579-C7A5-D5E1-C004F1EAB0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0EF4B6-5005-7028-3923-93C873AAC3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9E356C-1E75-E784-EB61-6AEC750ABE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BCE383A-EAAB-B2F4-EB4C-66937AF214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BBA6B36-86AB-F8BD-FCCD-6E818EC6BD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4740231-5CB0-E154-4DF0-6C7BD6C15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8A73F77-3596-1012-9824-8D9D9A8FC7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2437073-FE4E-BAFC-C9F5-4ADF6AA1F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344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63951-C807-5BE0-D464-4329245A2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86E2965-A97B-07EA-B49C-A19C2664E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9BA8972-362C-40EC-9ECA-95F74B704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2140F1-2493-78F3-A980-1014A1922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553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36052C6-DB11-BF53-E224-0D094888C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493C65C-7A84-7BE0-1CE2-B950F6ABC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86B25D9-2FD6-7711-FA69-DDE52299A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440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217C40-EDD8-B0ED-662F-2CA3D19DEA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7F11D1-C382-A9BB-D09C-EE8686A417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3AC2A4-404B-0682-BA3C-FDD55A13CE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46A4D6-41A1-4701-6523-407CFA0C0D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283262-FC5B-416E-61BB-F7AFAC44F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11B1E4-ACD5-4280-4A44-13B2C5D1F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211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CEBA2C-FF2C-D825-90A0-0169BA265E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C26FC5-2B94-86C8-5FA5-C91B813292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48DF98-6995-8CFA-821B-13AA8F48CC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FAD951-27ED-17FB-6DA9-456AEA1AA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07F111-4BD9-21E8-2E25-E764A7BA00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23457A-C740-E272-3B50-74AE4CB00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535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F4EF226-EB0B-BB99-5277-FC9EB0D2E1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DAC767-1CB0-8A2B-1D04-BC6DE3A5F6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B6A47E-8F7F-7BCA-51D2-76D347E97C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5201B0-3E1C-46D3-B9F7-FD5D22458021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E663CD-E64E-FB43-0917-2778665B6B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1BFBCA-D2D0-7599-A761-143CB8278F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D5BE1-0FC5-4928-BE69-F12917A69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71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BE67E02-26F5-7148-A500-1AF6E70C5A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5351" y="0"/>
            <a:ext cx="4922331" cy="681459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ADC6FAE-9A07-B899-133C-664A96A83E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92954" y="800560"/>
            <a:ext cx="5327076" cy="521211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CBFB466-4106-5700-EBAD-C5F105A84BB4}"/>
              </a:ext>
            </a:extLst>
          </p:cNvPr>
          <p:cNvSpPr txBox="1"/>
          <p:nvPr/>
        </p:nvSpPr>
        <p:spPr>
          <a:xfrm>
            <a:off x="-12762" y="-72001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4685FFD-1D03-D686-C998-1130C00EA923}"/>
              </a:ext>
            </a:extLst>
          </p:cNvPr>
          <p:cNvSpPr txBox="1"/>
          <p:nvPr/>
        </p:nvSpPr>
        <p:spPr>
          <a:xfrm>
            <a:off x="796909" y="328109"/>
            <a:ext cx="336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E9AA634-10CA-CAA5-2029-5E3CDC673CA2}"/>
              </a:ext>
            </a:extLst>
          </p:cNvPr>
          <p:cNvSpPr txBox="1"/>
          <p:nvPr/>
        </p:nvSpPr>
        <p:spPr>
          <a:xfrm>
            <a:off x="6096000" y="328109"/>
            <a:ext cx="336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817643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B46E5603-8A24-D025-85DA-43BAFB8101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349" y="938914"/>
            <a:ext cx="7192678" cy="3000688"/>
          </a:xfrm>
          <a:prstGeom prst="rect">
            <a:avLst/>
          </a:prstGeom>
        </p:spPr>
      </p:pic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6F91FC65-4755-145B-BF78-EF5FBB2C936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395682" y="4006242"/>
            <a:ext cx="7400636" cy="2851758"/>
          </a:xfr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7FDD865-F771-2D1D-B10C-BFED43B08E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13052" y="100316"/>
            <a:ext cx="3950714" cy="3772645"/>
          </a:xfrm>
          <a:prstGeom prst="rect">
            <a:avLst/>
          </a:prstGeom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726FE52A-9F7A-E7EB-3250-B8436CC56772}"/>
              </a:ext>
            </a:extLst>
          </p:cNvPr>
          <p:cNvCxnSpPr>
            <a:cxnSpLocks/>
          </p:cNvCxnSpPr>
          <p:nvPr/>
        </p:nvCxnSpPr>
        <p:spPr>
          <a:xfrm flipV="1">
            <a:off x="2907839" y="9009"/>
            <a:ext cx="0" cy="3465869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0">
            <a:extLst>
              <a:ext uri="{FF2B5EF4-FFF2-40B4-BE49-F238E27FC236}">
                <a16:creationId xmlns:a16="http://schemas.microsoft.com/office/drawing/2014/main" id="{16099329-D246-1C6D-4EC5-3D700B77038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64376" y="1174667"/>
            <a:ext cx="1799807" cy="162394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6F9BE93-74B9-96A8-89B2-AEBCD95AEA8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32124" y="292388"/>
            <a:ext cx="1753946" cy="1472062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0D13BF1B-5D8D-B820-EF44-C46E1CF4C5BD}"/>
              </a:ext>
            </a:extLst>
          </p:cNvPr>
          <p:cNvSpPr txBox="1"/>
          <p:nvPr/>
        </p:nvSpPr>
        <p:spPr>
          <a:xfrm>
            <a:off x="856830" y="0"/>
            <a:ext cx="185678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First trimester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B671FAC-A4D2-92AB-F4C4-B6E99B5CE3C3}"/>
              </a:ext>
            </a:extLst>
          </p:cNvPr>
          <p:cNvSpPr txBox="1"/>
          <p:nvPr/>
        </p:nvSpPr>
        <p:spPr>
          <a:xfrm>
            <a:off x="4364376" y="9009"/>
            <a:ext cx="173161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econd trimester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CB7FE94-2B40-330A-EAF3-3FC0EEEE09CE}"/>
              </a:ext>
            </a:extLst>
          </p:cNvPr>
          <p:cNvSpPr txBox="1"/>
          <p:nvPr/>
        </p:nvSpPr>
        <p:spPr>
          <a:xfrm>
            <a:off x="139878" y="0"/>
            <a:ext cx="336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226468F-56E4-CBED-59CF-09539C809F7B}"/>
              </a:ext>
            </a:extLst>
          </p:cNvPr>
          <p:cNvSpPr txBox="1"/>
          <p:nvPr/>
        </p:nvSpPr>
        <p:spPr>
          <a:xfrm>
            <a:off x="2395591" y="3788256"/>
            <a:ext cx="336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9BECF4D-D00C-A453-145F-5805CD3DDE6E}"/>
              </a:ext>
            </a:extLst>
          </p:cNvPr>
          <p:cNvSpPr txBox="1"/>
          <p:nvPr/>
        </p:nvSpPr>
        <p:spPr>
          <a:xfrm>
            <a:off x="7594455" y="0"/>
            <a:ext cx="336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3F6001B-EE6B-3908-109F-2D01C6C3F4AA}"/>
              </a:ext>
            </a:extLst>
          </p:cNvPr>
          <p:cNvSpPr txBox="1"/>
          <p:nvPr/>
        </p:nvSpPr>
        <p:spPr>
          <a:xfrm>
            <a:off x="5503178" y="531400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6185C88-B655-4120-36BE-815F83F72C37}"/>
              </a:ext>
            </a:extLst>
          </p:cNvPr>
          <p:cNvSpPr txBox="1"/>
          <p:nvPr/>
        </p:nvSpPr>
        <p:spPr>
          <a:xfrm>
            <a:off x="7889163" y="614517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A7A194D-AF80-6256-0230-B3BF17AEB109}"/>
              </a:ext>
            </a:extLst>
          </p:cNvPr>
          <p:cNvSpPr txBox="1"/>
          <p:nvPr/>
        </p:nvSpPr>
        <p:spPr>
          <a:xfrm>
            <a:off x="8354916" y="57746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43C38D5-0F0B-A520-10AD-0CA44705B84F}"/>
              </a:ext>
            </a:extLst>
          </p:cNvPr>
          <p:cNvSpPr txBox="1"/>
          <p:nvPr/>
        </p:nvSpPr>
        <p:spPr>
          <a:xfrm>
            <a:off x="9213591" y="139511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1AA22E6-302D-0C42-4456-69DC030EAB42}"/>
              </a:ext>
            </a:extLst>
          </p:cNvPr>
          <p:cNvSpPr txBox="1"/>
          <p:nvPr/>
        </p:nvSpPr>
        <p:spPr>
          <a:xfrm>
            <a:off x="10100245" y="65908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EE6FAA1-F174-BCEE-E866-611CCAD708F4}"/>
              </a:ext>
            </a:extLst>
          </p:cNvPr>
          <p:cNvSpPr txBox="1"/>
          <p:nvPr/>
        </p:nvSpPr>
        <p:spPr>
          <a:xfrm>
            <a:off x="0" y="4186018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9898168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56D53CDD-E3B6-B3AA-6BF5-C30614AE3D1B}"/>
              </a:ext>
            </a:extLst>
          </p:cNvPr>
          <p:cNvSpPr txBox="1"/>
          <p:nvPr/>
        </p:nvSpPr>
        <p:spPr>
          <a:xfrm>
            <a:off x="148967" y="4824937"/>
            <a:ext cx="52549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ving or speaking so slowly that other people could have noticed? </a:t>
            </a:r>
          </a:p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 so fidgety or restless that you have been moving a lot more than usual?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25FB057-CAEC-0238-D4D3-5DBA3732DBF9}"/>
              </a:ext>
            </a:extLst>
          </p:cNvPr>
          <p:cNvSpPr txBox="1"/>
          <p:nvPr/>
        </p:nvSpPr>
        <p:spPr>
          <a:xfrm>
            <a:off x="2011511" y="1518973"/>
            <a:ext cx="28600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eeling down, depressed, or hopeless?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49FBEFB-A236-543E-089F-8460CDDBB0A5}"/>
              </a:ext>
            </a:extLst>
          </p:cNvPr>
          <p:cNvSpPr txBox="1"/>
          <p:nvPr/>
        </p:nvSpPr>
        <p:spPr>
          <a:xfrm>
            <a:off x="1310499" y="2087941"/>
            <a:ext cx="39380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ouble falling or staying asleep, or sleeping too much?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0EB8023-5D3B-DA4B-D9D1-E036972956C1}"/>
              </a:ext>
            </a:extLst>
          </p:cNvPr>
          <p:cNvSpPr txBox="1"/>
          <p:nvPr/>
        </p:nvSpPr>
        <p:spPr>
          <a:xfrm>
            <a:off x="1902164" y="2610472"/>
            <a:ext cx="26132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eeling tired or having little energy?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9E6E82A-8A28-CD34-3480-E8A6E97E2A16}"/>
              </a:ext>
            </a:extLst>
          </p:cNvPr>
          <p:cNvSpPr txBox="1"/>
          <p:nvPr/>
        </p:nvSpPr>
        <p:spPr>
          <a:xfrm>
            <a:off x="2149026" y="3145318"/>
            <a:ext cx="21194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or appetite or overeating?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9D5F504-E357-1810-9639-AD4B500A3D4E}"/>
              </a:ext>
            </a:extLst>
          </p:cNvPr>
          <p:cNvSpPr txBox="1"/>
          <p:nvPr/>
        </p:nvSpPr>
        <p:spPr>
          <a:xfrm>
            <a:off x="1106003" y="3668851"/>
            <a:ext cx="39901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eeling bad about yourself — or that you are a failure or</a:t>
            </a:r>
          </a:p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have let yourself or your family down?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A87B410-DA36-B50F-4172-49153FDFE2F4}"/>
              </a:ext>
            </a:extLst>
          </p:cNvPr>
          <p:cNvSpPr txBox="1"/>
          <p:nvPr/>
        </p:nvSpPr>
        <p:spPr>
          <a:xfrm>
            <a:off x="1297371" y="4255969"/>
            <a:ext cx="35388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ouble concentrating on things, such as reading </a:t>
            </a:r>
          </a:p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 newspaper or watching television?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D42085E-9EC6-D6A6-DAC4-609F8FDADCC2}"/>
              </a:ext>
            </a:extLst>
          </p:cNvPr>
          <p:cNvSpPr txBox="1"/>
          <p:nvPr/>
        </p:nvSpPr>
        <p:spPr>
          <a:xfrm>
            <a:off x="1891286" y="954243"/>
            <a:ext cx="29803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Little interest or pleasure in doing things?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8BB822B-F82D-482A-9B4D-BB3A1B10E4B9}"/>
              </a:ext>
            </a:extLst>
          </p:cNvPr>
          <p:cNvSpPr txBox="1"/>
          <p:nvPr/>
        </p:nvSpPr>
        <p:spPr>
          <a:xfrm>
            <a:off x="1079884" y="5442092"/>
            <a:ext cx="41701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oughts that you would be better off dead, or thoughts of </a:t>
            </a:r>
          </a:p>
          <a:p>
            <a:r>
              <a:rPr 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urting yourself in some way?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2BBA54C-2C69-B7F4-F2BC-A1A6F9B7E4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03932" y="733784"/>
            <a:ext cx="6560517" cy="539043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6CA95CA-9CD6-6119-A347-EBEDDC14E85A}"/>
              </a:ext>
            </a:extLst>
          </p:cNvPr>
          <p:cNvSpPr txBox="1"/>
          <p:nvPr/>
        </p:nvSpPr>
        <p:spPr>
          <a:xfrm>
            <a:off x="246888" y="71366"/>
            <a:ext cx="13331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16237257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545E694F-001B-7254-7CC1-F02D884C7D5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208660" y="4494350"/>
            <a:ext cx="3828653" cy="1924689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A6EA014-B1C6-63BB-B6B8-E1E2A40188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10748" y="251924"/>
            <a:ext cx="3685963" cy="182026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C5FEB08-5D7F-1E82-A35C-ABB6419940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61863" y="2363650"/>
            <a:ext cx="3775450" cy="182026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5652C22-902C-B30A-B434-8DC594B8DF4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81672" y="2218785"/>
            <a:ext cx="4084261" cy="196465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6AD0A12-7D80-38BF-C42B-5BAB331093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81673" y="4494351"/>
            <a:ext cx="4026987" cy="197268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12F3D3A-8926-6540-E8C9-1C943B45F63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81672" y="188916"/>
            <a:ext cx="4080191" cy="197911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BD085F9-B1BC-5A14-3AC1-5C89217548E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4687" y="2168031"/>
            <a:ext cx="3936160" cy="199732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5A0B921C-B904-6459-9D94-5FD9B4FCFE99}"/>
              </a:ext>
            </a:extLst>
          </p:cNvPr>
          <p:cNvSpPr txBox="1"/>
          <p:nvPr/>
        </p:nvSpPr>
        <p:spPr>
          <a:xfrm>
            <a:off x="-65587" y="1983365"/>
            <a:ext cx="258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3356C88-CA0A-7528-04FB-FE5CEDDB04C4}"/>
              </a:ext>
            </a:extLst>
          </p:cNvPr>
          <p:cNvSpPr txBox="1"/>
          <p:nvPr/>
        </p:nvSpPr>
        <p:spPr>
          <a:xfrm>
            <a:off x="4063862" y="-75179"/>
            <a:ext cx="258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CCDF0B5-31D5-863C-F294-6ABF4888B9B6}"/>
              </a:ext>
            </a:extLst>
          </p:cNvPr>
          <p:cNvSpPr txBox="1"/>
          <p:nvPr/>
        </p:nvSpPr>
        <p:spPr>
          <a:xfrm>
            <a:off x="8208660" y="-18280"/>
            <a:ext cx="258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3A89D73-0C04-2EE4-DEE0-F2DF5AD452AA}"/>
              </a:ext>
            </a:extLst>
          </p:cNvPr>
          <p:cNvSpPr txBox="1"/>
          <p:nvPr/>
        </p:nvSpPr>
        <p:spPr>
          <a:xfrm>
            <a:off x="4052188" y="2051211"/>
            <a:ext cx="258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8C824F-B1DD-2701-1C54-2EBC8A96B3EC}"/>
              </a:ext>
            </a:extLst>
          </p:cNvPr>
          <p:cNvSpPr txBox="1"/>
          <p:nvPr/>
        </p:nvSpPr>
        <p:spPr>
          <a:xfrm>
            <a:off x="8156857" y="1992425"/>
            <a:ext cx="258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F662E77-AC1F-0402-9753-E48ED57EBF5C}"/>
              </a:ext>
            </a:extLst>
          </p:cNvPr>
          <p:cNvSpPr txBox="1"/>
          <p:nvPr/>
        </p:nvSpPr>
        <p:spPr>
          <a:xfrm>
            <a:off x="4044545" y="4121233"/>
            <a:ext cx="258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DFAD793-D4E0-027E-9A14-2AD352CC2F5A}"/>
              </a:ext>
            </a:extLst>
          </p:cNvPr>
          <p:cNvSpPr txBox="1"/>
          <p:nvPr/>
        </p:nvSpPr>
        <p:spPr>
          <a:xfrm>
            <a:off x="8124771" y="4115639"/>
            <a:ext cx="258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7D1DC77-1E61-FE1E-5E7F-951872B2889C}"/>
              </a:ext>
            </a:extLst>
          </p:cNvPr>
          <p:cNvSpPr txBox="1"/>
          <p:nvPr/>
        </p:nvSpPr>
        <p:spPr>
          <a:xfrm>
            <a:off x="129914" y="0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34802557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C5BB1EE9-38F6-9C71-70DA-C4D4526678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28743" y="1266032"/>
            <a:ext cx="3963257" cy="347702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6F523C8-D7AC-24DD-6293-9BCCBF5E39B1}"/>
              </a:ext>
            </a:extLst>
          </p:cNvPr>
          <p:cNvSpPr txBox="1"/>
          <p:nvPr/>
        </p:nvSpPr>
        <p:spPr>
          <a:xfrm>
            <a:off x="-68084" y="897973"/>
            <a:ext cx="336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5C08314-BBA5-7ADA-B4B0-3F7C443458B1}"/>
              </a:ext>
            </a:extLst>
          </p:cNvPr>
          <p:cNvSpPr txBox="1"/>
          <p:nvPr/>
        </p:nvSpPr>
        <p:spPr>
          <a:xfrm>
            <a:off x="4162992" y="896700"/>
            <a:ext cx="336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F5B25F4-B75D-FDFD-C024-AF9A64DD4295}"/>
              </a:ext>
            </a:extLst>
          </p:cNvPr>
          <p:cNvSpPr txBox="1"/>
          <p:nvPr/>
        </p:nvSpPr>
        <p:spPr>
          <a:xfrm>
            <a:off x="8162102" y="835868"/>
            <a:ext cx="336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A32335F-4B51-A413-9410-09F004EB1727}"/>
              </a:ext>
            </a:extLst>
          </p:cNvPr>
          <p:cNvSpPr txBox="1"/>
          <p:nvPr/>
        </p:nvSpPr>
        <p:spPr>
          <a:xfrm>
            <a:off x="129914" y="0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64A3DF22-F630-E5F1-7718-F7B05BF6AC0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62" y="1286670"/>
            <a:ext cx="4018097" cy="345639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D7562D6-8849-7FB4-A502-6EBDEC83109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44626" y="1286670"/>
            <a:ext cx="4072655" cy="35033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68082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FEB6FF3-0C27-C009-316F-C6FA1A3900AD}"/>
              </a:ext>
            </a:extLst>
          </p:cNvPr>
          <p:cNvSpPr txBox="1"/>
          <p:nvPr/>
        </p:nvSpPr>
        <p:spPr>
          <a:xfrm>
            <a:off x="129914" y="0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79EF609-8307-7A62-797B-671FD7A375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94791" y="0"/>
            <a:ext cx="778461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80322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2</Words>
  <Application>Microsoft Office PowerPoint</Application>
  <PresentationFormat>Widescreen</PresentationFormat>
  <Paragraphs>51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ng, Yongchao</dc:creator>
  <cp:lastModifiedBy>Huang, Yongchao</cp:lastModifiedBy>
  <cp:revision>1</cp:revision>
  <dcterms:created xsi:type="dcterms:W3CDTF">2023-07-13T04:13:32Z</dcterms:created>
  <dcterms:modified xsi:type="dcterms:W3CDTF">2023-07-13T04:14:08Z</dcterms:modified>
</cp:coreProperties>
</file>